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710344-9669-466F-B757-CF5148AE080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5A73E0-1499-471B-8EA6-FBB8B7D8FA9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47F057-7E8E-4BCB-B343-58E09249D34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D00BCE-55AE-42B9-BD7E-47B94FC87BE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118C21-CA4D-43E7-9BA2-7DDBAF7CC2C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8CA421-5097-44EA-A74B-3AA2CC0E424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5655D9-1A98-4B56-8BA1-D15FAA4BF65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0A2D97-AC52-47A4-ADFF-6F55ADA5CA0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5DE502-2323-434C-8B11-FFE4AD4137B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96337E-5812-4ADC-8BB0-CD1EC9D6CA9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1F6CA2-DBD8-4AAA-84C2-3BCDC6D1318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D65883-EED2-4FCA-9497-B13524F7B56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  <a:ea typeface="Arial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DB3059B-67C7-46D2-8AF0-09103BA2D322}" type="datetime">
              <a:rPr b="0" lang="en-US" sz="1200" spc="-1" strike="noStrike">
                <a:solidFill>
                  <a:srgbClr val="898989"/>
                </a:solidFill>
                <a:latin typeface="Calibri"/>
                <a:ea typeface="Arial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  <a:ea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54D8163-B328-4A8B-8D6E-1D2104DBC97E}" type="slidenum">
              <a:rPr b="0" lang="en-US" sz="1200" spc="-1" strike="noStrike">
                <a:solidFill>
                  <a:srgbClr val="898989"/>
                </a:solidFill>
                <a:latin typeface="Calibri"/>
                <a:ea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wmf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19"/>
          <p:cNvSpPr/>
          <p:nvPr/>
        </p:nvSpPr>
        <p:spPr>
          <a:xfrm>
            <a:off x="620640" y="1114560"/>
            <a:ext cx="5545080" cy="4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table 4: 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x proportional regression hazard models according the ANXA1 expression in all invasive breast cancers from the BCAC.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2" name="Object 1"/>
          <p:cNvGraphicFramePr/>
          <p:nvPr/>
        </p:nvGraphicFramePr>
        <p:xfrm>
          <a:off x="700200" y="1719360"/>
          <a:ext cx="5457600" cy="570528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43" name="Object 1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700200" y="1719360"/>
                    <a:ext cx="5457600" cy="57052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02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11-01T11:57:37Z</dcterms:created>
  <dc:creator>Marcelo Sobral Leite</dc:creator>
  <dc:description/>
  <dc:language>en-US</dc:language>
  <cp:lastModifiedBy>Marcelo Sobral-Leite</cp:lastModifiedBy>
  <cp:lastPrinted>2014-09-08T08:30:29Z</cp:lastPrinted>
  <dcterms:modified xsi:type="dcterms:W3CDTF">2015-04-29T15:19:46Z</dcterms:modified>
  <cp:revision>413</cp:revision>
  <dc:subject/>
  <dc:title>Slide 1</dc:title>
</cp:coreProperties>
</file>